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>
      <p:cViewPr varScale="1">
        <p:scale>
          <a:sx n="64" d="100"/>
          <a:sy n="64" d="100"/>
        </p:scale>
        <p:origin x="100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9D717-3104-4ED5-A899-933B09A990E7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1C88B-C2B2-477B-8C0A-B9360E751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794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9D717-3104-4ED5-A899-933B09A990E7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1C88B-C2B2-477B-8C0A-B9360E751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9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9D717-3104-4ED5-A899-933B09A990E7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1C88B-C2B2-477B-8C0A-B9360E751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337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9D717-3104-4ED5-A899-933B09A990E7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1C88B-C2B2-477B-8C0A-B9360E751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944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9D717-3104-4ED5-A899-933B09A990E7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1C88B-C2B2-477B-8C0A-B9360E751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982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9D717-3104-4ED5-A899-933B09A990E7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1C88B-C2B2-477B-8C0A-B9360E751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748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9D717-3104-4ED5-A899-933B09A990E7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1C88B-C2B2-477B-8C0A-B9360E751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456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9D717-3104-4ED5-A899-933B09A990E7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1C88B-C2B2-477B-8C0A-B9360E751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2674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9D717-3104-4ED5-A899-933B09A990E7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1C88B-C2B2-477B-8C0A-B9360E751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7944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9D717-3104-4ED5-A899-933B09A990E7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1C88B-C2B2-477B-8C0A-B9360E751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8277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9D717-3104-4ED5-A899-933B09A990E7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1C88B-C2B2-477B-8C0A-B9360E751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062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09D717-3104-4ED5-A899-933B09A990E7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01C88B-C2B2-477B-8C0A-B9360E7512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442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A903AB4-608F-4135-92E7-A24ABAAAFAC7}"/>
              </a:ext>
            </a:extLst>
          </p:cNvPr>
          <p:cNvSpPr txBox="1"/>
          <p:nvPr/>
        </p:nvSpPr>
        <p:spPr>
          <a:xfrm>
            <a:off x="331582" y="205057"/>
            <a:ext cx="38666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rum</a:t>
            </a:r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undance of </a:t>
            </a:r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s</a:t>
            </a:r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assifier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D7423686-E050-48F6-8E6F-A55CEE76CA42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63610" y="667819"/>
          <a:ext cx="6718853" cy="3668565"/>
        </p:xfrm>
        <a:graphic>
          <a:graphicData uri="http://schemas.openxmlformats.org/drawingml/2006/table">
            <a:tbl>
              <a:tblPr/>
              <a:tblGrid>
                <a:gridCol w="763326">
                  <a:extLst>
                    <a:ext uri="{9D8B030D-6E8A-4147-A177-3AD203B41FA5}">
                      <a16:colId xmlns:a16="http://schemas.microsoft.com/office/drawing/2014/main" val="2674990936"/>
                    </a:ext>
                  </a:extLst>
                </a:gridCol>
                <a:gridCol w="3633746">
                  <a:extLst>
                    <a:ext uri="{9D8B030D-6E8A-4147-A177-3AD203B41FA5}">
                      <a16:colId xmlns:a16="http://schemas.microsoft.com/office/drawing/2014/main" val="3246746935"/>
                    </a:ext>
                  </a:extLst>
                </a:gridCol>
                <a:gridCol w="850789">
                  <a:extLst>
                    <a:ext uri="{9D8B030D-6E8A-4147-A177-3AD203B41FA5}">
                      <a16:colId xmlns:a16="http://schemas.microsoft.com/office/drawing/2014/main" val="800795640"/>
                    </a:ext>
                  </a:extLst>
                </a:gridCol>
                <a:gridCol w="1470992">
                  <a:extLst>
                    <a:ext uri="{9D8B030D-6E8A-4147-A177-3AD203B41FA5}">
                      <a16:colId xmlns:a16="http://schemas.microsoft.com/office/drawing/2014/main" val="4043164979"/>
                    </a:ext>
                  </a:extLst>
                </a:gridCol>
              </a:tblGrid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prot</a:t>
                      </a:r>
                      <a:r>
                        <a:rPr lang="en-US" sz="105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ccession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77" marR="5377" marT="53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 description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77" marR="5377" marT="53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ID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77" marR="5377" marT="53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sma abundance </a:t>
                      </a:r>
                    </a:p>
                    <a:p>
                      <a:pPr algn="l" fontAlgn="b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x-</a:t>
                      </a:r>
                      <a:r>
                        <a:rPr lang="en-US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b</a:t>
                      </a:r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5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ptideatlas</a:t>
                      </a:r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021</a:t>
                      </a:r>
                    </a:p>
                  </a:txBody>
                  <a:tcPr marL="5377" marR="5377" marT="537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2606026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9NXD2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otubularin-related protein 10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MR10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1197527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7568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DH dehydrogenase [ubiquinone] 1 beta subcomplex subunit 7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UFB7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 ppm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0392369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15746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osin light chain kinase, smooth muscle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LK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 ppm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9655693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8WWM9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globin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GB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8973058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48723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t shock 70 kDa protein 13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PA13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6 ppm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5080094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07919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chrome b-c1 complex subunit 6, mitochondrial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QCRH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4 ppm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674117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01009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pha-1-antitrypsin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PINA1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551 ppm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0054304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14141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ptin-6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PTIN6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5 ppm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8160026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94874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3 UFM1-protein </a:t>
                      </a:r>
                      <a:r>
                        <a:rPr lang="pt-BR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gase</a:t>
                      </a:r>
                      <a:r>
                        <a:rPr lang="pt-BR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FL1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ppm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0968215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22105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nascin</a:t>
                      </a:r>
                      <a:r>
                        <a:rPr lang="pt-BR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X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XB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8 ppm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4963377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9P000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M domain-containing protein 9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MD9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 ppm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2701249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03950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giogenin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G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6 ppm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1129065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9H223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H domain-containing protein 4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HD4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 ppm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7083299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9H0E2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ll-interacting protein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LLIP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 ppm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4525034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9H254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trin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eta chain, non-erythrocytic 4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TBN4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ppm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8636821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9NR48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stone-lysine N-methyltransferase ASH1L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H1L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1265950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42785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sosomal Pro-X carboxypeptidase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CP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5 ppm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4684390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9UBR2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hepsin Z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SZ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1 ppm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3918797"/>
                  </a:ext>
                </a:extLst>
              </a:tr>
              <a:tr h="131877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55854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mall ubiquitin-related modifier 3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MO3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 ppm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9618343"/>
                  </a:ext>
                </a:extLst>
              </a:tr>
              <a:tr h="1289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62829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S </a:t>
                      </a:r>
                      <a:r>
                        <a:rPr lang="pt-BR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bosomal</a:t>
                      </a:r>
                      <a:r>
                        <a:rPr lang="pt-BR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t-BR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r>
                        <a:rPr lang="pt-BR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23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PL23</a:t>
                      </a:r>
                    </a:p>
                  </a:txBody>
                  <a:tcPr marL="5377" marR="5377" marT="537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9 ppm</a:t>
                      </a:r>
                    </a:p>
                  </a:txBody>
                  <a:tcPr marL="7333" marR="7333" marT="73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95312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738467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70</Words>
  <Application>Microsoft Office PowerPoint</Application>
  <PresentationFormat>Widescreen</PresentationFormat>
  <Paragraphs>8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oteomica</dc:creator>
  <cp:lastModifiedBy>Proteomica</cp:lastModifiedBy>
  <cp:revision>1</cp:revision>
  <dcterms:created xsi:type="dcterms:W3CDTF">2023-09-19T10:19:42Z</dcterms:created>
  <dcterms:modified xsi:type="dcterms:W3CDTF">2023-09-19T10:20:29Z</dcterms:modified>
</cp:coreProperties>
</file>